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0" r:id="rId2"/>
    <p:sldId id="281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Supplemental Figure 1" id="{3A7B2EA1-79CB-40C4-A569-EA9F137E0D69}">
          <p14:sldIdLst>
            <p14:sldId id="280"/>
          </p14:sldIdLst>
        </p14:section>
        <p14:section name="Supplemental Figure 2" id="{F64937EE-051A-41A1-B19F-D17392925512}">
          <p14:sldIdLst>
            <p14:sldId id="281"/>
          </p14:sldIdLst>
        </p14:section>
      </p14:section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34" d="100"/>
          <a:sy n="34" d="100"/>
        </p:scale>
        <p:origin x="2132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3C72D-CDF0-475C-92A8-928F67E7B41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963F3-8506-41D7-B375-869B41B8D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9274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3C72D-CDF0-475C-92A8-928F67E7B41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963F3-8506-41D7-B375-869B41B8D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7288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3C72D-CDF0-475C-92A8-928F67E7B41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963F3-8506-41D7-B375-869B41B8D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9554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3C72D-CDF0-475C-92A8-928F67E7B41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963F3-8506-41D7-B375-869B41B8D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3869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3C72D-CDF0-475C-92A8-928F67E7B41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963F3-8506-41D7-B375-869B41B8D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0677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3C72D-CDF0-475C-92A8-928F67E7B41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963F3-8506-41D7-B375-869B41B8D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91207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3C72D-CDF0-475C-92A8-928F67E7B41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963F3-8506-41D7-B375-869B41B8D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425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3C72D-CDF0-475C-92A8-928F67E7B41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963F3-8506-41D7-B375-869B41B8D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58297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3C72D-CDF0-475C-92A8-928F67E7B41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963F3-8506-41D7-B375-869B41B8D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2924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3C72D-CDF0-475C-92A8-928F67E7B41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963F3-8506-41D7-B375-869B41B8D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95580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53C72D-CDF0-475C-92A8-928F67E7B41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963F3-8506-41D7-B375-869B41B8D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46265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53C72D-CDF0-475C-92A8-928F67E7B418}" type="datetimeFigureOut">
              <a:rPr lang="en-US" smtClean="0"/>
              <a:t>1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4963F3-8506-41D7-B375-869B41B8DC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45700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98217B61-40FA-1B0D-AE8D-71712FF9D7F6}"/>
              </a:ext>
            </a:extLst>
          </p:cNvPr>
          <p:cNvGraphicFramePr>
            <a:graphicFrameLocks noChangeAspect="1"/>
          </p:cNvGraphicFramePr>
          <p:nvPr/>
        </p:nvGraphicFramePr>
        <p:xfrm>
          <a:off x="0" y="0"/>
          <a:ext cx="3260725" cy="3048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7218770" imgH="6749084" progId="Prism10.Document">
                  <p:embed/>
                </p:oleObj>
              </mc:Choice>
              <mc:Fallback>
                <p:oleObj name="Prism 10" r:id="rId2" imgW="7218770" imgH="6749084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98217B61-40FA-1B0D-AE8D-71712FF9D7F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0"/>
                        <a:ext cx="3260725" cy="3048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F1C79CB5-BE09-299E-BFB4-ADD571A1DF62}"/>
              </a:ext>
            </a:extLst>
          </p:cNvPr>
          <p:cNvSpPr txBox="1"/>
          <p:nvPr/>
        </p:nvSpPr>
        <p:spPr>
          <a:xfrm>
            <a:off x="0" y="3130130"/>
            <a:ext cx="6858000" cy="13984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600" b="1" i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1</a:t>
            </a:r>
            <a:r>
              <a:rPr lang="en-US" sz="1600" i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Overall T cell abundance was not altered in KEAP1 KO LL2 murine lung tumors</a:t>
            </a:r>
            <a:r>
              <a:rPr lang="en-US" sz="16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Flow cytometry was used to assess T cell abundance in the LL2 orthotopic lung tumor model. CD8</a:t>
            </a:r>
            <a:r>
              <a:rPr lang="en-US" sz="1600" baseline="30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US" sz="16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CD4</a:t>
            </a:r>
            <a:r>
              <a:rPr lang="en-US" sz="1600" baseline="30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US" sz="16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 cell abundances are graphed as a percentage of overall CD45</a:t>
            </a:r>
            <a:r>
              <a:rPr lang="en-US" sz="1600" baseline="300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 </a:t>
            </a:r>
            <a:r>
              <a:rPr lang="en-US" sz="16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mune cells identified in lung tumors. Each point corresponds with one mouse.</a:t>
            </a:r>
          </a:p>
        </p:txBody>
      </p:sp>
    </p:spTree>
    <p:extLst>
      <p:ext uri="{BB962C8B-B14F-4D97-AF65-F5344CB8AC3E}">
        <p14:creationId xmlns:p14="http://schemas.microsoft.com/office/powerpoint/2010/main" val="12784220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diagram of a number of different types of plants&#10;&#10;Description automatically generated with medium confidence">
            <a:extLst>
              <a:ext uri="{FF2B5EF4-FFF2-40B4-BE49-F238E27FC236}">
                <a16:creationId xmlns:a16="http://schemas.microsoft.com/office/drawing/2014/main" id="{E3E2D419-5CCE-BF32-FF24-41A18DFF3B0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4876800" cy="48768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95BC609-86B7-EF19-939A-D4A32D003233}"/>
              </a:ext>
            </a:extLst>
          </p:cNvPr>
          <p:cNvSpPr txBox="1"/>
          <p:nvPr/>
        </p:nvSpPr>
        <p:spPr>
          <a:xfrm>
            <a:off x="0" y="4684067"/>
            <a:ext cx="6858000" cy="21867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600" b="1" i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</a:t>
            </a:r>
            <a:r>
              <a:rPr lang="en-US" sz="1600" i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TIMER2.0 predicts increased M2-like macrophages in KEAP1-mutant human squamous cell lung carcinomas</a:t>
            </a:r>
            <a:r>
              <a:rPr lang="en-US" sz="16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Violin plot of estimated M2-like macrophage infiltration in </a:t>
            </a:r>
            <a:r>
              <a:rPr lang="en-US" sz="1600" i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EAP1</a:t>
            </a:r>
            <a:r>
              <a:rPr lang="en-US" sz="16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mutant vs </a:t>
            </a:r>
            <a:r>
              <a:rPr lang="en-US" sz="1600" i="1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EAP1</a:t>
            </a:r>
            <a:r>
              <a:rPr lang="en-US" sz="16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WT squamous lung carcinomas identified from TCGA sequencing data using the TIDE algorithm. Each point corresponds to the estimation from one human tumor.</a:t>
            </a: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br>
              <a:rPr lang="en-US" sz="1600" kern="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</a:br>
            <a:r>
              <a:rPr lang="en-US" sz="1600" dirty="0"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</a:p>
        </p:txBody>
      </p:sp>
    </p:spTree>
    <p:extLst>
      <p:ext uri="{BB962C8B-B14F-4D97-AF65-F5344CB8AC3E}">
        <p14:creationId xmlns:p14="http://schemas.microsoft.com/office/powerpoint/2010/main" val="3736464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</TotalTime>
  <Words>119</Words>
  <Application>Microsoft Office PowerPoint</Application>
  <PresentationFormat>Widescreen</PresentationFormat>
  <Paragraphs>3</Paragraphs>
  <Slides>2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Office Theme</vt:lpstr>
      <vt:lpstr>Prism 10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pher Occhiuto</dc:creator>
  <cp:lastModifiedBy>Christopher Occhiuto</cp:lastModifiedBy>
  <cp:revision>1</cp:revision>
  <dcterms:created xsi:type="dcterms:W3CDTF">2024-01-03T14:40:14Z</dcterms:created>
  <dcterms:modified xsi:type="dcterms:W3CDTF">2024-01-03T14:47:56Z</dcterms:modified>
</cp:coreProperties>
</file>